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69CA3-B373-49E0-85E8-2EECDD4696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ABBB5-02CA-4D88-B10D-AFAD9D6AAD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2A8B4-0DE9-4284-ACFA-FC02BF6D11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EBC97-7151-4338-9C39-8D52CA1281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864D5-91AA-4E52-87F8-00998EEF0A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5AB95-5669-4CE8-9FB9-B21F04393A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120C8-8B9E-4E46-8A7D-99776866AB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B762D-1A01-41DF-BA8A-E813976508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355AE-DE52-4AC2-919F-315F5C3321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23284-9151-4CB7-95CE-F9D5E73239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E5C00-1D43-4B2A-B5B1-38F53D053F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16DE9-6CB1-4802-9377-C06CE414AF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8A787C-A332-4FF9-B106-EFF795A1B9E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838080" y="4800600"/>
            <a:ext cx="5257800" cy="260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 S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mediate IFN-</a:t>
            </a:r>
            <a:r>
              <a:rPr b="1" lang="en-US" sz="11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 day 6 IL-10 responses to PPD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Fold increase (mean ± 95% CI) in IFN-γ production in response to PPD (compared with  cells cultured without antigen) at recruitment for each subject. (B,C) Immediate IFN-γ at recruitment compared to at 12 months later in Rural 1 (B) and Rural 2 (C) subjects. Horizontal line = median; box = 2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h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7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h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rcentiles; whiskers = minimum and maximum values. Paire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s were used to analyse differences between the two time point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 Concentration (mean ± 95% CI) of IL-10 in 6 day, PPD-stimulated culture supernatants at recruitment. (E,F) IL-10 concentrations in 6 day, PPD-stimulated culture supernatants at recruitment and 12 months later in Rural 1 (E) and Rural 2 (F) subjects. Horizontal line = median; box = 2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h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75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th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ercentiles; whiskers = minimum and maximum values. Paire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tests were used to analyse differences between the two time point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4"/>
          <p:cNvGraphicFramePr/>
          <p:nvPr/>
        </p:nvGraphicFramePr>
        <p:xfrm>
          <a:off x="4121280" y="1585800"/>
          <a:ext cx="1212840" cy="1005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121280" y="1585800"/>
                    <a:ext cx="1212840" cy="100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Object 3"/>
          <p:cNvGraphicFramePr/>
          <p:nvPr/>
        </p:nvGraphicFramePr>
        <p:xfrm>
          <a:off x="3025800" y="1585800"/>
          <a:ext cx="1165320" cy="1005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025800" y="1585800"/>
                    <a:ext cx="1165320" cy="100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TextBox 44"/>
          <p:cNvSpPr/>
          <p:nvPr/>
        </p:nvSpPr>
        <p:spPr>
          <a:xfrm>
            <a:off x="3349080" y="15066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ural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51"/>
          <p:cNvSpPr/>
          <p:nvPr/>
        </p:nvSpPr>
        <p:spPr>
          <a:xfrm>
            <a:off x="4488840" y="152388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ural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21"/>
          <p:cNvSpPr/>
          <p:nvPr/>
        </p:nvSpPr>
        <p:spPr>
          <a:xfrm rot="20356800">
            <a:off x="2855880" y="2592000"/>
            <a:ext cx="81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 recrui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1"/>
          <p:cNvSpPr/>
          <p:nvPr/>
        </p:nvSpPr>
        <p:spPr>
          <a:xfrm rot="20356800">
            <a:off x="4049640" y="2579400"/>
            <a:ext cx="81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t recruitm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2"/>
          <p:cNvSpPr/>
          <p:nvPr/>
        </p:nvSpPr>
        <p:spPr>
          <a:xfrm rot="20356800">
            <a:off x="3513600" y="2547720"/>
            <a:ext cx="65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 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2"/>
          <p:cNvSpPr/>
          <p:nvPr/>
        </p:nvSpPr>
        <p:spPr>
          <a:xfrm rot="20356800">
            <a:off x="4707720" y="2550960"/>
            <a:ext cx="65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 Month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6"/>
          <p:cNvSpPr/>
          <p:nvPr/>
        </p:nvSpPr>
        <p:spPr>
          <a:xfrm>
            <a:off x="2815200" y="1278000"/>
            <a:ext cx="175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mmediate IFN-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respo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48"/>
          <p:cNvSpPr/>
          <p:nvPr/>
        </p:nvSpPr>
        <p:spPr>
          <a:xfrm>
            <a:off x="1988280" y="163980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49"/>
          <p:cNvSpPr/>
          <p:nvPr/>
        </p:nvSpPr>
        <p:spPr>
          <a:xfrm>
            <a:off x="3127320" y="163980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1"/>
          <p:cNvSpPr/>
          <p:nvPr/>
        </p:nvSpPr>
        <p:spPr>
          <a:xfrm>
            <a:off x="4274280" y="1636560"/>
            <a:ext cx="29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7"/>
          <p:cNvSpPr/>
          <p:nvPr/>
        </p:nvSpPr>
        <p:spPr>
          <a:xfrm>
            <a:off x="1983600" y="2467080"/>
            <a:ext cx="333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it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2265120" y="2467080"/>
            <a:ext cx="464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ural 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2633400" y="2467080"/>
            <a:ext cx="464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Rural 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"/>
          <p:cNvSpPr/>
          <p:nvPr/>
        </p:nvSpPr>
        <p:spPr>
          <a:xfrm rot="16200000">
            <a:off x="1387440" y="2004840"/>
            <a:ext cx="79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old incre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64"/>
          <p:cNvGrpSpPr/>
          <p:nvPr/>
        </p:nvGrpSpPr>
        <p:grpSpPr>
          <a:xfrm>
            <a:off x="1628640" y="2895480"/>
            <a:ext cx="3854160" cy="1616040"/>
            <a:chOff x="1628640" y="2895480"/>
            <a:chExt cx="3854160" cy="1616040"/>
          </a:xfrm>
        </p:grpSpPr>
        <p:sp>
          <p:nvSpPr>
            <p:cNvPr id="61" name="TextBox 21"/>
            <p:cNvSpPr/>
            <p:nvPr/>
          </p:nvSpPr>
          <p:spPr>
            <a:xfrm rot="20356800">
              <a:off x="3010320" y="4158000"/>
              <a:ext cx="81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ecruitme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1"/>
            <p:cNvSpPr/>
            <p:nvPr/>
          </p:nvSpPr>
          <p:spPr>
            <a:xfrm rot="20356800">
              <a:off x="4103640" y="4144320"/>
              <a:ext cx="81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t recruitme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2"/>
            <p:cNvSpPr/>
            <p:nvPr/>
          </p:nvSpPr>
          <p:spPr>
            <a:xfrm rot="20356800">
              <a:off x="3667320" y="411408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 Month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2"/>
            <p:cNvSpPr/>
            <p:nvPr/>
          </p:nvSpPr>
          <p:spPr>
            <a:xfrm rot="20356800">
              <a:off x="4807800" y="411516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 Month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4"/>
            <p:cNvSpPr/>
            <p:nvPr/>
          </p:nvSpPr>
          <p:spPr>
            <a:xfrm>
              <a:off x="3425400" y="306540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ural 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51"/>
            <p:cNvSpPr/>
            <p:nvPr/>
          </p:nvSpPr>
          <p:spPr>
            <a:xfrm>
              <a:off x="4568760" y="304776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ural 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7"/>
            <p:cNvSpPr/>
            <p:nvPr/>
          </p:nvSpPr>
          <p:spPr>
            <a:xfrm>
              <a:off x="2979360" y="2895480"/>
              <a:ext cx="144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 6 IL-10 respo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52"/>
            <p:cNvSpPr/>
            <p:nvPr/>
          </p:nvSpPr>
          <p:spPr>
            <a:xfrm>
              <a:off x="1987560" y="3239280"/>
              <a:ext cx="295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D.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53"/>
            <p:cNvSpPr/>
            <p:nvPr/>
          </p:nvSpPr>
          <p:spPr>
            <a:xfrm>
              <a:off x="3187800" y="3240720"/>
              <a:ext cx="289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E.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54"/>
            <p:cNvSpPr/>
            <p:nvPr/>
          </p:nvSpPr>
          <p:spPr>
            <a:xfrm>
              <a:off x="4318560" y="3242520"/>
              <a:ext cx="282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F.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71" name="Object 1"/>
            <p:cNvGraphicFramePr/>
            <p:nvPr/>
          </p:nvGraphicFramePr>
          <p:xfrm>
            <a:off x="1752480" y="3151080"/>
            <a:ext cx="1280520" cy="100548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72" name="Object 1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752480" y="3151080"/>
                      <a:ext cx="1280520" cy="1005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3" name="Text Box 102"/>
            <p:cNvSpPr/>
            <p:nvPr/>
          </p:nvSpPr>
          <p:spPr>
            <a:xfrm rot="16200000">
              <a:off x="1216440" y="3565440"/>
              <a:ext cx="102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oncentration (pg/ml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80"/>
            <p:cNvSpPr/>
            <p:nvPr/>
          </p:nvSpPr>
          <p:spPr>
            <a:xfrm>
              <a:off x="2415600" y="3194640"/>
              <a:ext cx="5493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p = 0.0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" name="Group 81"/>
            <p:cNvGrpSpPr/>
            <p:nvPr/>
          </p:nvGrpSpPr>
          <p:grpSpPr>
            <a:xfrm>
              <a:off x="2481120" y="3358440"/>
              <a:ext cx="365760" cy="36360"/>
              <a:chOff x="2481120" y="3358440"/>
              <a:chExt cx="365760" cy="36360"/>
            </a:xfrm>
          </p:grpSpPr>
          <p:sp>
            <p:nvSpPr>
              <p:cNvPr id="76" name="Straight Connector 51"/>
              <p:cNvSpPr/>
              <p:nvPr/>
            </p:nvSpPr>
            <p:spPr>
              <a:xfrm flipH="1">
                <a:off x="2845440" y="3359880"/>
                <a:ext cx="144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Straight Connector 52"/>
              <p:cNvSpPr/>
              <p:nvPr/>
            </p:nvSpPr>
            <p:spPr>
              <a:xfrm flipH="1">
                <a:off x="2481120" y="3359880"/>
                <a:ext cx="144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Straight Connector 53"/>
              <p:cNvSpPr/>
              <p:nvPr/>
            </p:nvSpPr>
            <p:spPr>
              <a:xfrm>
                <a:off x="2481120" y="3358440"/>
                <a:ext cx="3643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TextBox 17"/>
            <p:cNvSpPr/>
            <p:nvPr/>
          </p:nvSpPr>
          <p:spPr>
            <a:xfrm>
              <a:off x="2005560" y="4033080"/>
              <a:ext cx="333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ity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8"/>
            <p:cNvSpPr/>
            <p:nvPr/>
          </p:nvSpPr>
          <p:spPr>
            <a:xfrm>
              <a:off x="2274120" y="4033080"/>
              <a:ext cx="46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ural 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9"/>
            <p:cNvSpPr/>
            <p:nvPr/>
          </p:nvSpPr>
          <p:spPr>
            <a:xfrm>
              <a:off x="2595240" y="4033080"/>
              <a:ext cx="464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ural 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82" name="Object 41"/>
            <p:cNvGraphicFramePr/>
            <p:nvPr/>
          </p:nvGraphicFramePr>
          <p:xfrm>
            <a:off x="3006720" y="3151080"/>
            <a:ext cx="1260720" cy="100548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83" name="Object 41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006720" y="3151080"/>
                      <a:ext cx="1260720" cy="1005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84" name="Object 42"/>
            <p:cNvGraphicFramePr/>
            <p:nvPr/>
          </p:nvGraphicFramePr>
          <p:xfrm>
            <a:off x="4101480" y="3151080"/>
            <a:ext cx="1309320" cy="100548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85" name="Object 42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101480" y="3151080"/>
                      <a:ext cx="1309320" cy="1005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aphicFrame>
        <p:nvGraphicFramePr>
          <p:cNvPr id="86" name="Object 43"/>
          <p:cNvGraphicFramePr/>
          <p:nvPr/>
        </p:nvGraphicFramePr>
        <p:xfrm>
          <a:off x="1882800" y="1584360"/>
          <a:ext cx="1165320" cy="10065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87" name="Object 43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882800" y="1584360"/>
                    <a:ext cx="1165320" cy="100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7T09:16:49Z</dcterms:created>
  <dc:creator>Tay</dc:creator>
  <dc:description/>
  <dc:language>en-US</dc:language>
  <cp:lastModifiedBy>IIMMERIL</cp:lastModifiedBy>
  <dcterms:modified xsi:type="dcterms:W3CDTF">2011-01-04T13:52:49Z</dcterms:modified>
  <cp:revision>31</cp:revision>
  <dc:subject/>
  <dc:title>Slide 1</dc:title>
</cp:coreProperties>
</file>